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19698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070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290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6164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262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477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6750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2325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804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7525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7715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393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07710" y="152823"/>
            <a:ext cx="4266386" cy="3121226"/>
          </a:xfr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69375" y="152823"/>
            <a:ext cx="4244657" cy="312122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7421" y="3379908"/>
            <a:ext cx="4291954" cy="312385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81734" y="3382537"/>
            <a:ext cx="4345923" cy="320369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299171" y="4510225"/>
            <a:ext cx="276732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ry figure 2. ROC curve in men </a:t>
            </a:r>
          </a:p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2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4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6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8 year follow up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5859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a)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689516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74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689515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d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3735651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3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박성근</cp:lastModifiedBy>
  <cp:revision>18</cp:revision>
  <dcterms:created xsi:type="dcterms:W3CDTF">2024-01-24T23:55:32Z</dcterms:created>
  <dcterms:modified xsi:type="dcterms:W3CDTF">2024-05-04T11:11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</Properties>
</file>